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599"/>
    <p:restoredTop sz="95313"/>
  </p:normalViewPr>
  <p:slideViewPr>
    <p:cSldViewPr snapToGrid="0" snapToObjects="1">
      <p:cViewPr varScale="1">
        <p:scale>
          <a:sx n="93" d="100"/>
          <a:sy n="93" d="100"/>
        </p:scale>
        <p:origin x="200" y="3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09E2-67CA-264A-AAA7-0458E962BAE8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F5E59-1CF4-3D48-8113-BA2012536E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32422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09E2-67CA-264A-AAA7-0458E962BAE8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F5E59-1CF4-3D48-8113-BA2012536E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9054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09E2-67CA-264A-AAA7-0458E962BAE8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F5E59-1CF4-3D48-8113-BA2012536E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37298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09E2-67CA-264A-AAA7-0458E962BAE8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F5E59-1CF4-3D48-8113-BA2012536E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0986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09E2-67CA-264A-AAA7-0458E962BAE8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F5E59-1CF4-3D48-8113-BA2012536E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5466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09E2-67CA-264A-AAA7-0458E962BAE8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F5E59-1CF4-3D48-8113-BA2012536E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65134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09E2-67CA-264A-AAA7-0458E962BAE8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F5E59-1CF4-3D48-8113-BA2012536E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00773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09E2-67CA-264A-AAA7-0458E962BAE8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F5E59-1CF4-3D48-8113-BA2012536E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66298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09E2-67CA-264A-AAA7-0458E962BAE8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F5E59-1CF4-3D48-8113-BA2012536E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71668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09E2-67CA-264A-AAA7-0458E962BAE8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F5E59-1CF4-3D48-8113-BA2012536E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98567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09E2-67CA-264A-AAA7-0458E962BAE8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F5E59-1CF4-3D48-8113-BA2012536E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77212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7809E2-67CA-264A-AAA7-0458E962BAE8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7F5E59-1CF4-3D48-8113-BA2012536E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7748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6122C7AE-9867-2D45-8636-A3BC0375DF11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449242" y="976402"/>
          <a:ext cx="5965969" cy="449867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257327">
                  <a:extLst>
                    <a:ext uri="{9D8B030D-6E8A-4147-A177-3AD203B41FA5}">
                      <a16:colId xmlns:a16="http://schemas.microsoft.com/office/drawing/2014/main" val="4057796477"/>
                    </a:ext>
                  </a:extLst>
                </a:gridCol>
                <a:gridCol w="1460793">
                  <a:extLst>
                    <a:ext uri="{9D8B030D-6E8A-4147-A177-3AD203B41FA5}">
                      <a16:colId xmlns:a16="http://schemas.microsoft.com/office/drawing/2014/main" val="1801102993"/>
                    </a:ext>
                  </a:extLst>
                </a:gridCol>
                <a:gridCol w="1247849">
                  <a:extLst>
                    <a:ext uri="{9D8B030D-6E8A-4147-A177-3AD203B41FA5}">
                      <a16:colId xmlns:a16="http://schemas.microsoft.com/office/drawing/2014/main" val="2162847406"/>
                    </a:ext>
                  </a:extLst>
                </a:gridCol>
              </a:tblGrid>
              <a:tr h="301915">
                <a:tc rowSpan="2">
                  <a:txBody>
                    <a:bodyPr/>
                    <a:lstStyle/>
                    <a:p>
                      <a:endParaRPr lang="ja-JP" sz="105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53714794"/>
                  </a:ext>
                </a:extLst>
              </a:tr>
              <a:tr h="301915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st trimester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rd trimester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2616659"/>
                  </a:ext>
                </a:extLst>
              </a:tr>
              <a:tr h="31169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US" sz="1200" u="sng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ease activity parameter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614766580"/>
                  </a:ext>
                </a:extLst>
              </a:tr>
              <a:tr h="31169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No achievement of LLDAS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3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3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84286673"/>
                  </a:ext>
                </a:extLst>
              </a:tr>
              <a:tr h="50319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No achievement of LLDA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without glucocorticoid dose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6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0639931"/>
                  </a:ext>
                </a:extLst>
              </a:tr>
              <a:tr h="319387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SLEDAI score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*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17005819"/>
                  </a:ext>
                </a:extLst>
              </a:tr>
              <a:tr h="319387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C3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52930824"/>
                  </a:ext>
                </a:extLst>
              </a:tr>
              <a:tr h="319387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C4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3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0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10400855"/>
                  </a:ext>
                </a:extLst>
              </a:tr>
              <a:tr h="319387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CH50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*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84941095"/>
                  </a:ext>
                </a:extLst>
              </a:tr>
              <a:tr h="319387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Titer of anti-dsDNA antibody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9938829"/>
                  </a:ext>
                </a:extLst>
              </a:tr>
              <a:tr h="319387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US" sz="1200" u="sng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atment agent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64107620"/>
                  </a:ext>
                </a:extLst>
              </a:tr>
              <a:tr h="319387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Glucocorticoid use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6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01422848"/>
                  </a:ext>
                </a:extLst>
              </a:tr>
              <a:tr h="532545">
                <a:tc>
                  <a:txBody>
                    <a:bodyPr/>
                    <a:lstStyle/>
                    <a:p>
                      <a:pPr indent="304800"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prednisolone dose during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pregnancy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0130965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6E42B74-C82E-DB4C-BF1E-1D7980EC16EE}"/>
              </a:ext>
            </a:extLst>
          </p:cNvPr>
          <p:cNvSpPr txBox="1"/>
          <p:nvPr/>
        </p:nvSpPr>
        <p:spPr>
          <a:xfrm>
            <a:off x="956396" y="443346"/>
            <a:ext cx="52093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3. Relevance to light-for-date</a:t>
            </a:r>
            <a:endParaRPr lang="ja-JP" altLang="ja-JP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6147D71-8618-024E-AC5A-43B429B55D44}"/>
              </a:ext>
            </a:extLst>
          </p:cNvPr>
          <p:cNvSpPr txBox="1"/>
          <p:nvPr/>
        </p:nvSpPr>
        <p:spPr>
          <a:xfrm>
            <a:off x="1094509" y="5638800"/>
            <a:ext cx="70519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Fisher’s exact test,  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#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Wilcoxon rank sum test, *; P&lt;0.05. SLEDAI; systemic lupus erythematosus disease activity index, LLDAS; lupus low disease activity state, anti-dsDNA antibody; anti-double stranded DNA antibody)</a:t>
            </a:r>
            <a:r>
              <a:rPr lang="ja-JP" altLang="ja-JP" sz="120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12318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1</Words>
  <Application>Microsoft Macintosh PowerPoint</Application>
  <PresentationFormat>画面に合わせる (4:3)</PresentationFormat>
  <Paragraphs>3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ＭＳ Ｐゴシック</vt:lpstr>
      <vt:lpstr>游ゴシック</vt:lpstr>
      <vt:lpstr>游ゴシック Light</vt:lpstr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User</dc:creator>
  <cp:lastModifiedBy>Microsoft Office User</cp:lastModifiedBy>
  <cp:revision>1</cp:revision>
  <dcterms:created xsi:type="dcterms:W3CDTF">2020-08-01T02:34:34Z</dcterms:created>
  <dcterms:modified xsi:type="dcterms:W3CDTF">2020-08-01T02:35:10Z</dcterms:modified>
</cp:coreProperties>
</file>